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0799763" cy="9359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6" d="100"/>
          <a:sy n="96" d="100"/>
        </p:scale>
        <p:origin x="132" y="-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531818"/>
            <a:ext cx="9179799" cy="325863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916115"/>
            <a:ext cx="8099822" cy="2259809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36874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5976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98328"/>
            <a:ext cx="2328699" cy="793208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98328"/>
            <a:ext cx="6851100" cy="793208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3844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5003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333478"/>
            <a:ext cx="9314796" cy="389345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263769"/>
            <a:ext cx="9314796" cy="2047477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5368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491640"/>
            <a:ext cx="4589899" cy="59387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491640"/>
            <a:ext cx="4589899" cy="59387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7610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98330"/>
            <a:ext cx="9314796" cy="1809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94476"/>
            <a:ext cx="4568805" cy="1124487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418964"/>
            <a:ext cx="4568805" cy="50287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94476"/>
            <a:ext cx="4591306" cy="1124487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418964"/>
            <a:ext cx="4591306" cy="50287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4376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3434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2867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623993"/>
            <a:ext cx="3483205" cy="218397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347654"/>
            <a:ext cx="5467380" cy="6651596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807970"/>
            <a:ext cx="3483205" cy="5202112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446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623993"/>
            <a:ext cx="3483205" cy="218397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347654"/>
            <a:ext cx="5467380" cy="6651596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807970"/>
            <a:ext cx="3483205" cy="5202112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6216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98330"/>
            <a:ext cx="9314796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491640"/>
            <a:ext cx="9314796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675243"/>
            <a:ext cx="2429947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00493-F941-4BF2-B660-C196F63D3BE7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675243"/>
            <a:ext cx="3644920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675243"/>
            <a:ext cx="2429947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338FE-DE7D-4144-B020-3CB472E73F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0745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8A401D78-C8CF-E57E-5F2C-504F29BBA8DF}"/>
              </a:ext>
            </a:extLst>
          </p:cNvPr>
          <p:cNvGrpSpPr/>
          <p:nvPr/>
        </p:nvGrpSpPr>
        <p:grpSpPr>
          <a:xfrm>
            <a:off x="754558" y="121099"/>
            <a:ext cx="9278829" cy="6800497"/>
            <a:chOff x="760466" y="1233981"/>
            <a:chExt cx="9278829" cy="6800497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5B7D7893-15F2-E7B7-65B7-805847E2A2A2}"/>
                </a:ext>
              </a:extLst>
            </p:cNvPr>
            <p:cNvSpPr/>
            <p:nvPr/>
          </p:nvSpPr>
          <p:spPr>
            <a:xfrm>
              <a:off x="873478" y="4053904"/>
              <a:ext cx="3009503" cy="2748829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49A75D9-3ED1-8873-B8F4-28505CFDCE8B}"/>
                </a:ext>
              </a:extLst>
            </p:cNvPr>
            <p:cNvSpPr/>
            <p:nvPr/>
          </p:nvSpPr>
          <p:spPr>
            <a:xfrm>
              <a:off x="3928512" y="4053904"/>
              <a:ext cx="3009503" cy="2759917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8FD7433-7B81-79B8-6BB8-BFACF1154560}"/>
                </a:ext>
              </a:extLst>
            </p:cNvPr>
            <p:cNvSpPr/>
            <p:nvPr/>
          </p:nvSpPr>
          <p:spPr>
            <a:xfrm>
              <a:off x="6983549" y="4053903"/>
              <a:ext cx="3009503" cy="2759917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CAE4D02-348F-6E69-BA51-1DB072F6B309}"/>
                </a:ext>
              </a:extLst>
            </p:cNvPr>
            <p:cNvSpPr txBox="1"/>
            <p:nvPr/>
          </p:nvSpPr>
          <p:spPr>
            <a:xfrm>
              <a:off x="803878" y="3996859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531CB4A-0C85-BD94-0AF8-02D9CDA0C6B0}"/>
                </a:ext>
              </a:extLst>
            </p:cNvPr>
            <p:cNvSpPr txBox="1"/>
            <p:nvPr/>
          </p:nvSpPr>
          <p:spPr>
            <a:xfrm>
              <a:off x="3840572" y="3996391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046B15D-0C18-7507-FACA-C46FF99234C6}"/>
                </a:ext>
              </a:extLst>
            </p:cNvPr>
            <p:cNvSpPr txBox="1"/>
            <p:nvPr/>
          </p:nvSpPr>
          <p:spPr>
            <a:xfrm>
              <a:off x="6895301" y="3990103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E15988B-636E-D893-DE62-811525087861}"/>
                </a:ext>
              </a:extLst>
            </p:cNvPr>
            <p:cNvSpPr/>
            <p:nvPr/>
          </p:nvSpPr>
          <p:spPr>
            <a:xfrm>
              <a:off x="3928512" y="1309968"/>
              <a:ext cx="3009503" cy="2686892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0D43152-4523-D941-0F79-5FD16F73A4F7}"/>
                </a:ext>
              </a:extLst>
            </p:cNvPr>
            <p:cNvSpPr/>
            <p:nvPr/>
          </p:nvSpPr>
          <p:spPr>
            <a:xfrm>
              <a:off x="873478" y="1309967"/>
              <a:ext cx="3009503" cy="2678159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EA0B511-4943-DAF3-68F5-46B2DDAB842A}"/>
                </a:ext>
              </a:extLst>
            </p:cNvPr>
            <p:cNvSpPr/>
            <p:nvPr/>
          </p:nvSpPr>
          <p:spPr>
            <a:xfrm>
              <a:off x="6983549" y="1309967"/>
              <a:ext cx="3009503" cy="2678159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94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80F57EA-742B-F2C2-95C6-10FB757409A9}"/>
                </a:ext>
              </a:extLst>
            </p:cNvPr>
            <p:cNvSpPr txBox="1"/>
            <p:nvPr/>
          </p:nvSpPr>
          <p:spPr>
            <a:xfrm>
              <a:off x="794895" y="1245231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2E16CDB-1B40-453E-5064-368950A2089E}"/>
                </a:ext>
              </a:extLst>
            </p:cNvPr>
            <p:cNvSpPr txBox="1"/>
            <p:nvPr/>
          </p:nvSpPr>
          <p:spPr>
            <a:xfrm>
              <a:off x="3855151" y="1233981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53EDF3E-06FC-8C58-C831-3AD18D06EBAC}"/>
                </a:ext>
              </a:extLst>
            </p:cNvPr>
            <p:cNvSpPr txBox="1"/>
            <p:nvPr/>
          </p:nvSpPr>
          <p:spPr>
            <a:xfrm>
              <a:off x="6903856" y="1242473"/>
              <a:ext cx="353781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2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77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4F13A4C-43D5-8A6A-0E05-B754A287566B}"/>
                </a:ext>
              </a:extLst>
            </p:cNvPr>
            <p:cNvSpPr txBox="1"/>
            <p:nvPr/>
          </p:nvSpPr>
          <p:spPr>
            <a:xfrm>
              <a:off x="905005" y="1246689"/>
              <a:ext cx="2977973" cy="310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17" dirty="0">
                  <a:latin typeface="Arial" panose="020B0604020202020204" pitchFamily="34" charset="0"/>
                  <a:cs typeface="Arial" panose="020B0604020202020204" pitchFamily="34" charset="0"/>
                </a:rPr>
                <a:t>Apigenin</a:t>
              </a:r>
              <a:endParaRPr lang="en-IN" sz="141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0043CA4-23AF-A963-F4B0-166531FC0C13}"/>
                </a:ext>
              </a:extLst>
            </p:cNvPr>
            <p:cNvSpPr txBox="1"/>
            <p:nvPr/>
          </p:nvSpPr>
          <p:spPr>
            <a:xfrm>
              <a:off x="3945948" y="1263220"/>
              <a:ext cx="3003944" cy="310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17" dirty="0">
                  <a:latin typeface="Arial" panose="020B0604020202020204" pitchFamily="34" charset="0"/>
                  <a:cs typeface="Arial" panose="020B0604020202020204" pitchFamily="34" charset="0"/>
                </a:rPr>
                <a:t>Eriodyctiol</a:t>
              </a:r>
              <a:endParaRPr lang="en-IN" sz="141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10D50FD-7FD4-F960-FFCE-E6E040887973}"/>
                </a:ext>
              </a:extLst>
            </p:cNvPr>
            <p:cNvSpPr txBox="1"/>
            <p:nvPr/>
          </p:nvSpPr>
          <p:spPr>
            <a:xfrm>
              <a:off x="6929923" y="1263220"/>
              <a:ext cx="2958905" cy="310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17" dirty="0" err="1">
                  <a:latin typeface="Arial" panose="020B0604020202020204" pitchFamily="34" charset="0"/>
                  <a:cs typeface="Arial" panose="020B0604020202020204" pitchFamily="34" charset="0"/>
                </a:rPr>
                <a:t>Hesperitin</a:t>
              </a:r>
              <a:endParaRPr lang="en-IN" sz="141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768E797-7DD1-4E76-9AA7-0B033D98506E}"/>
                </a:ext>
              </a:extLst>
            </p:cNvPr>
            <p:cNvSpPr txBox="1"/>
            <p:nvPr/>
          </p:nvSpPr>
          <p:spPr>
            <a:xfrm>
              <a:off x="881666" y="4023655"/>
              <a:ext cx="2958905" cy="310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17" dirty="0">
                  <a:latin typeface="Arial" panose="020B0604020202020204" pitchFamily="34" charset="0"/>
                  <a:cs typeface="Arial" panose="020B0604020202020204" pitchFamily="34" charset="0"/>
                </a:rPr>
                <a:t>Luteolin</a:t>
              </a:r>
              <a:endParaRPr lang="en-IN" sz="141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EBD36D0-F7C0-6FCD-582F-05FC1FADAF40}"/>
                </a:ext>
              </a:extLst>
            </p:cNvPr>
            <p:cNvSpPr txBox="1"/>
            <p:nvPr/>
          </p:nvSpPr>
          <p:spPr>
            <a:xfrm>
              <a:off x="3925979" y="4006077"/>
              <a:ext cx="3003944" cy="310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17" dirty="0">
                  <a:latin typeface="Arial" panose="020B0604020202020204" pitchFamily="34" charset="0"/>
                  <a:cs typeface="Arial" panose="020B0604020202020204" pitchFamily="34" charset="0"/>
                </a:rPr>
                <a:t>6-methoxyluteolin</a:t>
              </a:r>
              <a:endParaRPr lang="en-IN" sz="141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AE6FDA5-9827-D163-4AD9-4BF7DDABE92B}"/>
                </a:ext>
              </a:extLst>
            </p:cNvPr>
            <p:cNvSpPr txBox="1"/>
            <p:nvPr/>
          </p:nvSpPr>
          <p:spPr>
            <a:xfrm>
              <a:off x="6983546" y="3989878"/>
              <a:ext cx="3009505" cy="3376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GB" sz="1594" dirty="0">
                  <a:latin typeface="Times New Roman" panose="02020603050405020304" pitchFamily="18" charset="0"/>
                  <a:ea typeface="Calibri" panose="020F0502020204030204" pitchFamily="34" charset="0"/>
                </a:rPr>
                <a:t>Quercetin</a:t>
              </a:r>
              <a:endParaRPr lang="en-IN" sz="1594" dirty="0"/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98A743E-BBB6-293F-79A1-285622AFF8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70" t="4095" r="22738" b="15274"/>
            <a:stretch/>
          </p:blipFill>
          <p:spPr>
            <a:xfrm>
              <a:off x="1135144" y="1522050"/>
              <a:ext cx="2489867" cy="2447546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056CD348-DADB-3C03-E26A-3B111A16FC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34" t="15889" r="23038" b="23207"/>
            <a:stretch/>
          </p:blipFill>
          <p:spPr>
            <a:xfrm>
              <a:off x="3987382" y="1568464"/>
              <a:ext cx="2870940" cy="2347039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4853DD99-DA28-B2E7-AF93-613B0ED1D8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99" t="3977" r="27590" b="11926"/>
            <a:stretch/>
          </p:blipFill>
          <p:spPr>
            <a:xfrm>
              <a:off x="7516794" y="1559151"/>
              <a:ext cx="2112877" cy="2423013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F69A1F85-F039-933D-9A0D-9D15961CD9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73" t="4051" r="27355" b="15037"/>
            <a:stretch/>
          </p:blipFill>
          <p:spPr>
            <a:xfrm>
              <a:off x="1295540" y="4251161"/>
              <a:ext cx="2123275" cy="2530868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BE2E0729-0AC8-063F-C819-279D083F31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88" t="8840" r="24307" b="19555"/>
            <a:stretch/>
          </p:blipFill>
          <p:spPr>
            <a:xfrm>
              <a:off x="4040967" y="4251161"/>
              <a:ext cx="2741880" cy="2543629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412F8E62-CEB4-D1DE-4351-06F8927B6E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282" t="7777" r="24353" b="18890"/>
            <a:stretch/>
          </p:blipFill>
          <p:spPr>
            <a:xfrm>
              <a:off x="7104925" y="4264159"/>
              <a:ext cx="2766746" cy="2504873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2B9A6ED-B76D-B4F9-F8F2-873F4F9B71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69070"/>
            <a:stretch/>
          </p:blipFill>
          <p:spPr>
            <a:xfrm>
              <a:off x="760466" y="6887846"/>
              <a:ext cx="2442594" cy="1125863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F766FAF-C041-5F1F-5EF0-267DD24EA4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54582" r="6965" b="22386"/>
            <a:stretch/>
          </p:blipFill>
          <p:spPr>
            <a:xfrm>
              <a:off x="5147422" y="7068072"/>
              <a:ext cx="2551844" cy="94142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970159C-9AD3-1BA8-99EC-960BEA2344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30738" r="28375" b="44687"/>
            <a:stretch/>
          </p:blipFill>
          <p:spPr>
            <a:xfrm>
              <a:off x="3203060" y="7068072"/>
              <a:ext cx="1890072" cy="96640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26EE011-2A05-9F5F-35BD-0A4493DAAE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190" t="76968" r="12753"/>
            <a:stretch/>
          </p:blipFill>
          <p:spPr>
            <a:xfrm>
              <a:off x="7761171" y="7068072"/>
              <a:ext cx="2278124" cy="941424"/>
            </a:xfrm>
            <a:prstGeom prst="rect">
              <a:avLst/>
            </a:prstGeom>
          </p:spPr>
        </p:pic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1E8028A-CDA4-B2E4-07A8-BA0F7A761AA9}"/>
              </a:ext>
            </a:extLst>
          </p:cNvPr>
          <p:cNvSpPr txBox="1"/>
          <p:nvPr/>
        </p:nvSpPr>
        <p:spPr>
          <a:xfrm>
            <a:off x="794895" y="7058909"/>
            <a:ext cx="919815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Molecular docking interactions (2-dimensional representations) revealed ligand-protein interactions between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nkyrase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(ankyrin repeat cluster domain, PDB ID: 6URQ) and olive tree derived compounds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action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nkyra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with olive phytochemicals were demonstrated with Apigenin (A), Eriodyctiol (B), Hesperetin (C), Luteolin (D), 6-methoxyluteolin (E), Quercetin (F)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7647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9</TotalTime>
  <Words>80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NDAM SAIN</dc:creator>
  <cp:lastModifiedBy>Debdut Naskar</cp:lastModifiedBy>
  <cp:revision>7</cp:revision>
  <dcterms:created xsi:type="dcterms:W3CDTF">2023-10-16T04:17:06Z</dcterms:created>
  <dcterms:modified xsi:type="dcterms:W3CDTF">2024-04-29T16:05:38Z</dcterms:modified>
</cp:coreProperties>
</file>